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3"/>
  </p:notesMasterIdLst>
  <p:sldIdLst>
    <p:sldId id="261" r:id="rId5"/>
    <p:sldId id="278" r:id="rId6"/>
    <p:sldId id="280" r:id="rId7"/>
    <p:sldId id="281" r:id="rId8"/>
    <p:sldId id="282" r:id="rId9"/>
    <p:sldId id="284" r:id="rId10"/>
    <p:sldId id="283" r:id="rId11"/>
    <p:sldId id="273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6E7A68E-589B-4758-A4A1-0341DAAA4A0E}" v="10" dt="2025-04-28T01:02:20.27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37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notesMaster" Target="notesMasters/notesMaster1.xml"/><Relationship Id="rId18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nih.sharepoint.com/sites/NHGRI-MedicalGenomicsUnit/Shared%20Documents/General/Attitudes%20Survey%20AI%20in%20Medical%20Genetics/Attitudes%20Analy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nih.sharepoint.com/sites/NHGRI-MedicalGenomicsUnit/Shared%20Documents/General/Attitudes%20Survey%20AI%20in%20Medical%20Genetics/Attitudes%20Analysi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nih.sharepoint.com/sites/NHGRI-MedicalGenomicsUnit/Shared%20Documents/General/Attitudes%20Survey%20AI%20in%20Medical%20Genetics/Attitudes%20Analysi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nih.sharepoint.com/sites/NHGRI-MedicalGenomicsUnit/Shared%20Documents/General/Attitudes%20Survey%20AI%20in%20Medical%20Genetics/Attitudes%20Analysi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nih.sharepoint.com/sites/NHGRI-MedicalGenomicsUnit/Shared%20Documents/General/Attitudes%20Survey%20AI%20in%20Medical%20Genetics/Attitudes%20Analysi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nih.sharepoint.com/sites/NHGRI-MedicalGenomicsUnit/Shared%20Documents/General/Attitudes%20Survey%20AI%20in%20Medical%20Genetics/Attitudes%20Analysi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DB8E-4134-A639-E15D14DDDF3A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chemeClr val="accent1">
                    <a:lumMod val="20000"/>
                    <a:lumOff val="8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B8E-4134-A639-E15D14DDDF3A}"/>
              </c:ext>
            </c:extLst>
          </c:dPt>
          <c:cat>
            <c:strRef>
              <c:f>'Examples Professional'!$B$176:$F$176</c:f>
              <c:strCache>
                <c:ptCount val="5"/>
                <c:pt idx="0">
                  <c:v>Prior to this survey, were you aware that Face2Gene is an AI-based tool?</c:v>
                </c:pt>
                <c:pt idx="1">
                  <c:v>Do you think you will use  AI-based facial diagnostics, such as Face2Gene, as a differential diagnosis tool when you become a practicing GC?</c:v>
                </c:pt>
                <c:pt idx="3">
                  <c:v>Prior to this survey, were you aware that Face2Gene is an AI-based tool?</c:v>
                </c:pt>
                <c:pt idx="4">
                  <c:v>Have you used AI-based facial diagnostics, such as Face2Gene, as a differential diagnosis tool?</c:v>
                </c:pt>
              </c:strCache>
            </c:strRef>
          </c:cat>
          <c:val>
            <c:numRef>
              <c:f>'Examples Professional'!$B$177:$F$177</c:f>
              <c:numCache>
                <c:formatCode>General</c:formatCode>
                <c:ptCount val="5"/>
                <c:pt idx="0">
                  <c:v>0.47368421052631576</c:v>
                </c:pt>
                <c:pt idx="1">
                  <c:v>0.38596491228070173</c:v>
                </c:pt>
                <c:pt idx="3">
                  <c:v>0.71241830065359479</c:v>
                </c:pt>
                <c:pt idx="4">
                  <c:v>0.54901960784313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8E-4134-A639-E15D14DDDF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846868528"/>
        <c:axId val="1658725520"/>
      </c:barChart>
      <c:catAx>
        <c:axId val="18468685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58725520"/>
        <c:crosses val="autoZero"/>
        <c:auto val="1"/>
        <c:lblAlgn val="ctr"/>
        <c:lblOffset val="100"/>
        <c:noMultiLvlLbl val="0"/>
      </c:catAx>
      <c:valAx>
        <c:axId val="1658725520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Ye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468685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3CFC-4741-AD13-4D2CA3363D3B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CFC-4741-AD13-4D2CA3363D3B}"/>
              </c:ext>
            </c:extLst>
          </c:dPt>
          <c:cat>
            <c:strRef>
              <c:f>'Examples Professional'!$B$178:$G$178</c:f>
              <c:strCache>
                <c:ptCount val="6"/>
                <c:pt idx="0">
                  <c:v>Prior to this survey, were you aware AI was used in clinical genomic testing?</c:v>
                </c:pt>
                <c:pt idx="1">
                  <c:v>Do you think you will use molecular diagnostic companies that employ AI in their genomic testing process when you become a practicing GC?</c:v>
                </c:pt>
                <c:pt idx="3">
                  <c:v>Prior to this survey, were you aware AI was used in clinical genomic testing?</c:v>
                </c:pt>
                <c:pt idx="4">
                  <c:v>Does your lab utilize AI in the genetic/genomic testing process?</c:v>
                </c:pt>
                <c:pt idx="5">
                  <c:v>Have you used molecular diagnostic companies that employ AI in their genomic testing process?</c:v>
                </c:pt>
              </c:strCache>
            </c:strRef>
          </c:cat>
          <c:val>
            <c:numRef>
              <c:f>'Examples Professional'!$B$179:$G$179</c:f>
              <c:numCache>
                <c:formatCode>General</c:formatCode>
                <c:ptCount val="6"/>
                <c:pt idx="0">
                  <c:v>0.42105263157894735</c:v>
                </c:pt>
                <c:pt idx="1">
                  <c:v>0.75438596491228072</c:v>
                </c:pt>
                <c:pt idx="3">
                  <c:v>0.6797385620915033</c:v>
                </c:pt>
                <c:pt idx="4">
                  <c:v>0.75</c:v>
                </c:pt>
                <c:pt idx="5">
                  <c:v>0.620689655172413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CFC-4741-AD13-4D2CA3363D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68367856"/>
        <c:axId val="1795654160"/>
      </c:barChart>
      <c:catAx>
        <c:axId val="16683678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5654160"/>
        <c:crosses val="autoZero"/>
        <c:auto val="1"/>
        <c:lblAlgn val="ctr"/>
        <c:lblOffset val="100"/>
        <c:noMultiLvlLbl val="0"/>
      </c:catAx>
      <c:valAx>
        <c:axId val="1795654160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aseline="0"/>
                  <a:t>Ye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683678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2550-425F-A0E2-1E926FD6DB5F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550-425F-A0E2-1E926FD6DB5F}"/>
              </c:ext>
            </c:extLst>
          </c:dPt>
          <c:cat>
            <c:strRef>
              <c:f>'Examples Professional'!$B$180:$F$180</c:f>
              <c:strCache>
                <c:ptCount val="5"/>
                <c:pt idx="0">
                  <c:v>Prior to this survey, were you aware medical based chatbots like Gia use a type of AI?</c:v>
                </c:pt>
                <c:pt idx="1">
                  <c:v>Do you think your patients will use chatbots, like Gia, for genetic testing education and/or consenting when you become a practicing GC?</c:v>
                </c:pt>
                <c:pt idx="3">
                  <c:v>Prior to this survey, were you aware medical based chatbots like Gia use a type of AI?</c:v>
                </c:pt>
                <c:pt idx="4">
                  <c:v>Have your patients used chatbots, like Gia, for genetic testing education and/or consenting?</c:v>
                </c:pt>
              </c:strCache>
            </c:strRef>
          </c:cat>
          <c:val>
            <c:numRef>
              <c:f>'Examples Professional'!$B$181:$F$181</c:f>
              <c:numCache>
                <c:formatCode>General</c:formatCode>
                <c:ptCount val="5"/>
                <c:pt idx="0">
                  <c:v>0.75438596491228072</c:v>
                </c:pt>
                <c:pt idx="1">
                  <c:v>0.59649122807017541</c:v>
                </c:pt>
                <c:pt idx="3">
                  <c:v>0.73856209150326801</c:v>
                </c:pt>
                <c:pt idx="4">
                  <c:v>0.124183006535947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50-425F-A0E2-1E926FD6DB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814939408"/>
        <c:axId val="1795656080"/>
      </c:barChart>
      <c:catAx>
        <c:axId val="18149394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5656080"/>
        <c:crosses val="autoZero"/>
        <c:auto val="1"/>
        <c:lblAlgn val="ctr"/>
        <c:lblOffset val="100"/>
        <c:noMultiLvlLbl val="0"/>
      </c:catAx>
      <c:valAx>
        <c:axId val="1795656080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Ye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49394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chemeClr val="accent1">
                    <a:lumMod val="40000"/>
                    <a:lumOff val="6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292C-415A-A06F-2BE092AB33E9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92C-415A-A06F-2BE092AB33E9}"/>
              </c:ext>
            </c:extLst>
          </c:dPt>
          <c:cat>
            <c:strRef>
              <c:f>'Examples Professional'!$B$182:$F$182</c:f>
              <c:strCache>
                <c:ptCount val="5"/>
                <c:pt idx="0">
                  <c:v>Prior to this survey, were you aware that ChatGPT and LLMs are AI-based tools?</c:v>
                </c:pt>
                <c:pt idx="1">
                  <c:v>Do you think you will use ChatGPT or other LLM to assist in the diagnosis or management of a patient when you become a practicing GC?</c:v>
                </c:pt>
                <c:pt idx="3">
                  <c:v>Prior to this survey, were you aware that ChatGPT and LLMs are AI-based tools?</c:v>
                </c:pt>
                <c:pt idx="4">
                  <c:v>Have you used ChatGPT or other LLM to assist in the diagnosis or management of a patient?</c:v>
                </c:pt>
              </c:strCache>
            </c:strRef>
          </c:cat>
          <c:val>
            <c:numRef>
              <c:f>'Examples Professional'!$B$183:$F$183</c:f>
              <c:numCache>
                <c:formatCode>General</c:formatCode>
                <c:ptCount val="5"/>
                <c:pt idx="0">
                  <c:v>0.92982456140350878</c:v>
                </c:pt>
                <c:pt idx="1">
                  <c:v>0.24561403508771928</c:v>
                </c:pt>
                <c:pt idx="3">
                  <c:v>0.96078431372549022</c:v>
                </c:pt>
                <c:pt idx="4">
                  <c:v>0.118421052631578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92C-415A-A06F-2BE092AB33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818350288"/>
        <c:axId val="1625347552"/>
      </c:barChart>
      <c:catAx>
        <c:axId val="18183502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25347552"/>
        <c:crosses val="autoZero"/>
        <c:auto val="1"/>
        <c:lblAlgn val="ctr"/>
        <c:lblOffset val="100"/>
        <c:noMultiLvlLbl val="0"/>
      </c:catAx>
      <c:valAx>
        <c:axId val="1625347552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aseline="0"/>
                  <a:t>Yes (%)</a:t>
                </a:r>
              </a:p>
            </c:rich>
          </c:tx>
          <c:layout>
            <c:manualLayout>
              <c:xMode val="edge"/>
              <c:yMode val="edge"/>
              <c:x val="0.68511216001347452"/>
              <c:y val="0.9219917038732502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8350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DBD6-4172-8164-4CECFCE422B3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DBD6-4172-8164-4CECFCE422B3}"/>
              </c:ext>
            </c:extLst>
          </c:dPt>
          <c:cat>
            <c:strRef>
              <c:f>'Examples Professional'!$B$184:$F$184</c:f>
              <c:strCache>
                <c:ptCount val="5"/>
                <c:pt idx="0">
                  <c:v>Prior to this survey, were you aware AI-based tools could assist in constructing medical summaries and pedigrees?</c:v>
                </c:pt>
                <c:pt idx="1">
                  <c:v>Do you think you will use AI-prepared documents such as pedigrees and medical summaries in your practice when you become a practicing GC?</c:v>
                </c:pt>
                <c:pt idx="3">
                  <c:v>Prior to this survey, were you aware AI-based tools could assist in constructing medical summaries and pedigrees?</c:v>
                </c:pt>
                <c:pt idx="4">
                  <c:v>Do you use AI-prepared documents such as pedigrees and medical summaries in your practice?</c:v>
                </c:pt>
              </c:strCache>
            </c:strRef>
          </c:cat>
          <c:val>
            <c:numRef>
              <c:f>'Examples Professional'!$B$185:$F$185</c:f>
              <c:numCache>
                <c:formatCode>General</c:formatCode>
                <c:ptCount val="5"/>
                <c:pt idx="0">
                  <c:v>0.57894736842105265</c:v>
                </c:pt>
                <c:pt idx="1">
                  <c:v>0.63157894736842102</c:v>
                </c:pt>
                <c:pt idx="3">
                  <c:v>0.5816993464052288</c:v>
                </c:pt>
                <c:pt idx="4">
                  <c:v>0.111111111111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D6-4172-8164-4CECFCE422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814940800"/>
        <c:axId val="1795657520"/>
      </c:barChart>
      <c:catAx>
        <c:axId val="181494080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95657520"/>
        <c:crosses val="autoZero"/>
        <c:auto val="1"/>
        <c:lblAlgn val="ctr"/>
        <c:lblOffset val="100"/>
        <c:noMultiLvlLbl val="0"/>
      </c:catAx>
      <c:valAx>
        <c:axId val="1795657520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Ye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4940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EBF3-4F02-BF75-6519AE6708B9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BF3-4F02-BF75-6519AE6708B9}"/>
              </c:ext>
            </c:extLst>
          </c:dPt>
          <c:cat>
            <c:strRef>
              <c:f>'Examples Professional'!$B$186:$F$186</c:f>
              <c:strCache>
                <c:ptCount val="5"/>
                <c:pt idx="0">
                  <c:v>Prior to this survey, were you aware that some risk assessment tools use AI?</c:v>
                </c:pt>
                <c:pt idx="1">
                  <c:v>Do you think you will use AI-based risk assessment tools in your practice when you become a practicing GC?</c:v>
                </c:pt>
                <c:pt idx="3">
                  <c:v>Prior to this survey, were you aware that some risk assessment tools use AI?</c:v>
                </c:pt>
                <c:pt idx="4">
                  <c:v>Do you use AI-based risk assessment tools in your practice?</c:v>
                </c:pt>
              </c:strCache>
            </c:strRef>
          </c:cat>
          <c:val>
            <c:numRef>
              <c:f>'Examples Professional'!$B$187:$F$187</c:f>
              <c:numCache>
                <c:formatCode>General</c:formatCode>
                <c:ptCount val="5"/>
                <c:pt idx="0">
                  <c:v>0.42105263157894735</c:v>
                </c:pt>
                <c:pt idx="1">
                  <c:v>0.7192982456140351</c:v>
                </c:pt>
                <c:pt idx="3">
                  <c:v>0.52287581699346408</c:v>
                </c:pt>
                <c:pt idx="4">
                  <c:v>0.1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BF3-4F02-BF75-6519AE6708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457946144"/>
        <c:axId val="948868368"/>
      </c:barChart>
      <c:catAx>
        <c:axId val="14579461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48868368"/>
        <c:crosses val="autoZero"/>
        <c:auto val="1"/>
        <c:lblAlgn val="ctr"/>
        <c:lblOffset val="100"/>
        <c:noMultiLvlLbl val="0"/>
      </c:catAx>
      <c:valAx>
        <c:axId val="948868368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Ye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579461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919B91-0EDB-492C-BF8B-CA6AA67E9D5B}" type="datetimeFigureOut">
              <a:rPr lang="en-US" smtClean="0"/>
              <a:t>4/3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CD960A-AEAF-4730-9A0F-BDAE8D63E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307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2A15A-58BC-D5A9-E4A8-3BDB56E23A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F222547-399E-87ED-EF62-8658431744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18996A-4363-45FC-0665-9FA0F9457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2565-3F21-45E4-B4AF-D395E58BF74C}" type="datetimeFigureOut">
              <a:rPr lang="en-US" smtClean="0"/>
              <a:t>4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830363-9A4B-0508-52E3-A69E5DE90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4E99A6-9560-F5F1-8A93-868BFD298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BC6FE-785B-470F-A430-8725E8507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889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22C797-CF82-CBA7-0F2B-EF7864C58E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25F05B-925A-5DB2-7751-E36B98C8AD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C611C9-D62F-A05C-C2F6-F8D10B511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2565-3F21-45E4-B4AF-D395E58BF74C}" type="datetimeFigureOut">
              <a:rPr lang="en-US" smtClean="0"/>
              <a:t>4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7D3AC3-0856-6CA5-CB78-D3204CA16A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1B2668-D6D9-1366-ABC2-EFFD689F38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BC6FE-785B-470F-A430-8725E8507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539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C52D52-5696-2DD6-A4CF-D25E30E15E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CDEBD6-1B59-6ACE-51FA-A299708DA4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0346FF-BB49-39C2-6BD1-8B02452AB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2565-3F21-45E4-B4AF-D395E58BF74C}" type="datetimeFigureOut">
              <a:rPr lang="en-US" smtClean="0"/>
              <a:t>4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F3B240-1984-2BF0-0752-67B0EA1B0A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684A4E-AF14-CE78-71C5-03B44B6524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BC6FE-785B-470F-A430-8725E8507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063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B6AF23-D547-23C0-7855-32E6566F92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E22173-EB07-B6BB-7D03-2B0039EE54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BA73EB-F65B-4224-BBD4-9DFB3FD6A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2565-3F21-45E4-B4AF-D395E58BF74C}" type="datetimeFigureOut">
              <a:rPr lang="en-US" smtClean="0"/>
              <a:t>4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F9D942-AD2E-A3C0-BBE8-BB08E4E87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BAD842-23E6-5366-4EE1-29CEE3260D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BC6FE-785B-470F-A430-8725E8507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841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27CCED-6D73-26B2-F095-9B02354DB5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D62249-DDC6-4A31-66AD-797DA4A769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EC0C74-2573-F772-06AD-869BEE9A0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2565-3F21-45E4-B4AF-D395E58BF74C}" type="datetimeFigureOut">
              <a:rPr lang="en-US" smtClean="0"/>
              <a:t>4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3E3E47-EC3A-33C7-CDCF-F86348ED61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1F7DA4-E0AD-D1F5-4523-E0C047DD5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BC6FE-785B-470F-A430-8725E8507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323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208162-59FA-EF42-823F-3B4A28D519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32DB57-B56A-C58F-04C4-16A958ED32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4D8685-A6D3-613C-5591-A4F2D68E13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3EB005-87D1-545D-5638-9B8A56967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2565-3F21-45E4-B4AF-D395E58BF74C}" type="datetimeFigureOut">
              <a:rPr lang="en-US" smtClean="0"/>
              <a:t>4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BB9E6A-A7E8-A2FB-413F-0DF4E89D0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31968E-993E-61FB-DB29-510CD3C9B2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BC6FE-785B-470F-A430-8725E8507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014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096CFD-3580-BA68-7DC9-7AD995C8FB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592514-9C42-9812-5B0E-4F5A155829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24B992-0DE0-6963-DE6F-B8E7848996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D2FF20-4C54-7D92-FAB2-67AD7502CB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709457A-7CC0-CC38-B1F3-40432449F2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CF44D10-8EBA-044B-E529-8D464A9422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2565-3F21-45E4-B4AF-D395E58BF74C}" type="datetimeFigureOut">
              <a:rPr lang="en-US" smtClean="0"/>
              <a:t>4/3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34F00F8-F3FC-E36E-F8C2-D12A7866B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E96D448-3A06-A689-811A-7D44FCCF1D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BC6FE-785B-470F-A430-8725E8507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08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AF229D-6E15-73CC-11CC-C89F7D536A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18FEB00-E12C-997E-2F39-7D7DE81A2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2565-3F21-45E4-B4AF-D395E58BF74C}" type="datetimeFigureOut">
              <a:rPr lang="en-US" smtClean="0"/>
              <a:t>4/3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D0471E0-A5F9-E257-4F2A-0F0F67CC7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4CBC247-7752-4607-9AC1-D519130D8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BC6FE-785B-470F-A430-8725E8507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942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425CBEE-3B03-E006-417C-F94AA43983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2565-3F21-45E4-B4AF-D395E58BF74C}" type="datetimeFigureOut">
              <a:rPr lang="en-US" smtClean="0"/>
              <a:t>4/3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D74AE81-4270-B821-5907-4BF55C18E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BE383D-6CFE-AF33-2971-11ED31A63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BC6FE-785B-470F-A430-8725E8507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804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0064D9-5103-290F-217A-814ADE5BFF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A288D2-4B75-24E7-221B-5386614E3E6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4388FA-5872-2B4B-F8EC-09130C7314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D71EE6-E54A-6F04-EE5B-64223636F9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2565-3F21-45E4-B4AF-D395E58BF74C}" type="datetimeFigureOut">
              <a:rPr lang="en-US" smtClean="0"/>
              <a:t>4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190CAA-870D-47F3-7623-A4BBA33C5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9428C6-58D8-CEC0-1ECB-502230678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BC6FE-785B-470F-A430-8725E8507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9717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0379D4-CCB6-7891-DC85-CD64FBC5DE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6E6D9FE-FFB3-19AA-1C1D-CB83910B5D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D37052-31DD-4876-A772-639DC87881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7CA42A-782D-1210-F89F-0A55EC676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422565-3F21-45E4-B4AF-D395E58BF74C}" type="datetimeFigureOut">
              <a:rPr lang="en-US" smtClean="0"/>
              <a:t>4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ED0D70-F53D-7A45-6E90-F05319F62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1B9111-2508-044D-6479-F7AD097E7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BC6FE-785B-470F-A430-8725E8507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388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05B78AB-49D9-C2F6-2461-B17CCA2825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5E7B52-AAEF-73B6-DCB8-883674FCE8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23E2B6-6414-95E4-7929-887D795207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22565-3F21-45E4-B4AF-D395E58BF74C}" type="datetimeFigureOut">
              <a:rPr lang="en-US" smtClean="0"/>
              <a:t>4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D21006-C6DD-2C9B-F2CD-299B0C7950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B49D45-6972-D728-824A-E5AF04A897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5BC6FE-785B-470F-A430-8725E8507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331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9A6589-6E2C-C2AC-7A18-52ED2DB27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6659" y="0"/>
            <a:ext cx="10515600" cy="1325563"/>
          </a:xfrm>
        </p:spPr>
        <p:txBody>
          <a:bodyPr/>
          <a:lstStyle/>
          <a:p>
            <a:r>
              <a:rPr lang="en-US"/>
              <a:t>Age and experienc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DC3688D-1BC7-C92E-22FF-25EFF47ACD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6659" y="1303867"/>
            <a:ext cx="11105074" cy="3459471"/>
          </a:xfrm>
          <a:prstGeom prst="rect">
            <a:avLst/>
          </a:prstGeom>
        </p:spPr>
      </p:pic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2864A18B-A3BE-B570-DFCE-6FF0648DE2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723049"/>
              </p:ext>
            </p:extLst>
          </p:nvPr>
        </p:nvGraphicFramePr>
        <p:xfrm>
          <a:off x="8099521" y="4866574"/>
          <a:ext cx="1584036" cy="184213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92018">
                  <a:extLst>
                    <a:ext uri="{9D8B030D-6E8A-4147-A177-3AD203B41FA5}">
                      <a16:colId xmlns:a16="http://schemas.microsoft.com/office/drawing/2014/main" val="2043505846"/>
                    </a:ext>
                  </a:extLst>
                </a:gridCol>
                <a:gridCol w="792018">
                  <a:extLst>
                    <a:ext uri="{9D8B030D-6E8A-4147-A177-3AD203B41FA5}">
                      <a16:colId xmlns:a16="http://schemas.microsoft.com/office/drawing/2014/main" val="1860659661"/>
                    </a:ext>
                  </a:extLst>
                </a:gridCol>
              </a:tblGrid>
              <a:tr h="391933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Medical Genetics Residents and Fellow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3822758"/>
                  </a:ext>
                </a:extLst>
              </a:tr>
              <a:tr h="249605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ars in program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87063809"/>
                  </a:ext>
                </a:extLst>
              </a:tr>
              <a:tr h="24960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ar 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99582593"/>
                  </a:ext>
                </a:extLst>
              </a:tr>
              <a:tr h="24960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ar 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398212"/>
                  </a:ext>
                </a:extLst>
              </a:tr>
              <a:tr h="24960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ar 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34837217"/>
                  </a:ext>
                </a:extLst>
              </a:tr>
              <a:tr h="45178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ar 4 or mor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22118206"/>
                  </a:ext>
                </a:extLst>
              </a:tr>
            </a:tbl>
          </a:graphicData>
        </a:graphic>
      </p:graphicFrame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86135827-60EA-764F-F835-7673A30F86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9444867"/>
              </p:ext>
            </p:extLst>
          </p:nvPr>
        </p:nvGraphicFramePr>
        <p:xfrm>
          <a:off x="10048779" y="4866574"/>
          <a:ext cx="1219200" cy="116141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22447734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844317793"/>
                    </a:ext>
                  </a:extLst>
                </a:gridCol>
              </a:tblGrid>
              <a:tr h="243094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Genetic Counseling Student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1940775"/>
                  </a:ext>
                </a:extLst>
              </a:tr>
              <a:tr h="272202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ars in program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4205225"/>
                  </a:ext>
                </a:extLst>
              </a:tr>
              <a:tr h="27220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ar 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7291387"/>
                  </a:ext>
                </a:extLst>
              </a:tr>
              <a:tr h="27220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Year 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47829733"/>
                  </a:ext>
                </a:extLst>
              </a:tr>
            </a:tbl>
          </a:graphicData>
        </a:graphic>
      </p:graphicFrame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7D414BBA-995E-D466-0701-75933CBF52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8853668"/>
              </p:ext>
            </p:extLst>
          </p:nvPr>
        </p:nvGraphicFramePr>
        <p:xfrm>
          <a:off x="646659" y="4866574"/>
          <a:ext cx="7010400" cy="184213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346376">
                  <a:extLst>
                    <a:ext uri="{9D8B030D-6E8A-4147-A177-3AD203B41FA5}">
                      <a16:colId xmlns:a16="http://schemas.microsoft.com/office/drawing/2014/main" val="2278036723"/>
                    </a:ext>
                  </a:extLst>
                </a:gridCol>
                <a:gridCol w="972359">
                  <a:extLst>
                    <a:ext uri="{9D8B030D-6E8A-4147-A177-3AD203B41FA5}">
                      <a16:colId xmlns:a16="http://schemas.microsoft.com/office/drawing/2014/main" val="4015809162"/>
                    </a:ext>
                  </a:extLst>
                </a:gridCol>
                <a:gridCol w="848604">
                  <a:extLst>
                    <a:ext uri="{9D8B030D-6E8A-4147-A177-3AD203B41FA5}">
                      <a16:colId xmlns:a16="http://schemas.microsoft.com/office/drawing/2014/main" val="637321547"/>
                    </a:ext>
                  </a:extLst>
                </a:gridCol>
                <a:gridCol w="994457">
                  <a:extLst>
                    <a:ext uri="{9D8B030D-6E8A-4147-A177-3AD203B41FA5}">
                      <a16:colId xmlns:a16="http://schemas.microsoft.com/office/drawing/2014/main" val="3236145160"/>
                    </a:ext>
                  </a:extLst>
                </a:gridCol>
                <a:gridCol w="848604">
                  <a:extLst>
                    <a:ext uri="{9D8B030D-6E8A-4147-A177-3AD203B41FA5}">
                      <a16:colId xmlns:a16="http://schemas.microsoft.com/office/drawing/2014/main" val="299833819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effectLst/>
                        </a:rPr>
                        <a:t>Years in practice for Professional Participants 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edical Geneticis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enetic Counselo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dvanced Practice Providers and Nurse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otal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1229423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Less than 1 yea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950663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1 to 5 year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212972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5 to 10 year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5322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reater than 10 year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1281602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 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56060943"/>
                  </a:ext>
                </a:extLst>
              </a:tr>
              <a:tr h="190500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*2 participants did not report and 6 participants were resident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641119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8689144-D298-8F45-AE6D-31E2BC522252}"/>
              </a:ext>
            </a:extLst>
          </p:cNvPr>
          <p:cNvSpPr txBox="1"/>
          <p:nvPr/>
        </p:nvSpPr>
        <p:spPr>
          <a:xfrm>
            <a:off x="110836" y="73891"/>
            <a:ext cx="2364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13100331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F9A7C70-11FF-596C-A9F6-160361F5C127}"/>
              </a:ext>
            </a:extLst>
          </p:cNvPr>
          <p:cNvSpPr txBox="1"/>
          <p:nvPr/>
        </p:nvSpPr>
        <p:spPr>
          <a:xfrm>
            <a:off x="372479" y="369332"/>
            <a:ext cx="2404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acial diagnostics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96368C9B-482A-7A31-D83B-7940FDF1A87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6604949"/>
              </p:ext>
            </p:extLst>
          </p:nvPr>
        </p:nvGraphicFramePr>
        <p:xfrm>
          <a:off x="169682" y="1197204"/>
          <a:ext cx="11874536" cy="4732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39913BC2-1891-0E27-8CE3-2DC746071FFC}"/>
              </a:ext>
            </a:extLst>
          </p:cNvPr>
          <p:cNvSpPr txBox="1"/>
          <p:nvPr/>
        </p:nvSpPr>
        <p:spPr>
          <a:xfrm>
            <a:off x="2113203" y="1197204"/>
            <a:ext cx="2970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Genetics Professional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20B1ECB-11C5-B25A-93EC-E45DB4300F32}"/>
              </a:ext>
            </a:extLst>
          </p:cNvPr>
          <p:cNvSpPr txBox="1"/>
          <p:nvPr/>
        </p:nvSpPr>
        <p:spPr>
          <a:xfrm>
            <a:off x="1874981" y="3533719"/>
            <a:ext cx="2970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Genetics Counseling Students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CF2E7AD-608E-0908-F1AE-264AD72993BB}"/>
              </a:ext>
            </a:extLst>
          </p:cNvPr>
          <p:cNvSpPr txBox="1"/>
          <p:nvPr/>
        </p:nvSpPr>
        <p:spPr>
          <a:xfrm>
            <a:off x="0" y="0"/>
            <a:ext cx="3380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a</a:t>
            </a:r>
          </a:p>
        </p:txBody>
      </p:sp>
    </p:spTree>
    <p:extLst>
      <p:ext uri="{BB962C8B-B14F-4D97-AF65-F5344CB8AC3E}">
        <p14:creationId xmlns:p14="http://schemas.microsoft.com/office/powerpoint/2010/main" val="10203219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F9A7C70-11FF-596C-A9F6-160361F5C127}"/>
              </a:ext>
            </a:extLst>
          </p:cNvPr>
          <p:cNvSpPr txBox="1"/>
          <p:nvPr/>
        </p:nvSpPr>
        <p:spPr>
          <a:xfrm>
            <a:off x="358679" y="284787"/>
            <a:ext cx="2404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Molecular diagnostics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D5387F61-5A7B-7129-5C4F-6A4FD6EDFD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1709603"/>
              </p:ext>
            </p:extLst>
          </p:nvPr>
        </p:nvGraphicFramePr>
        <p:xfrm>
          <a:off x="247842" y="1388918"/>
          <a:ext cx="11685540" cy="40801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F06D61E-C166-279B-62DC-3F89FA36E3A9}"/>
              </a:ext>
            </a:extLst>
          </p:cNvPr>
          <p:cNvSpPr txBox="1"/>
          <p:nvPr/>
        </p:nvSpPr>
        <p:spPr>
          <a:xfrm>
            <a:off x="2113203" y="1197204"/>
            <a:ext cx="2970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Genetics Professional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1B64907-6AE3-EDB5-D149-AC2DBEFB4878}"/>
              </a:ext>
            </a:extLst>
          </p:cNvPr>
          <p:cNvSpPr txBox="1"/>
          <p:nvPr/>
        </p:nvSpPr>
        <p:spPr>
          <a:xfrm>
            <a:off x="1884219" y="3333143"/>
            <a:ext cx="2970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Genetics Counseling Students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D693D05-C1C4-0EF0-E244-C1F0250C5A14}"/>
              </a:ext>
            </a:extLst>
          </p:cNvPr>
          <p:cNvSpPr txBox="1"/>
          <p:nvPr/>
        </p:nvSpPr>
        <p:spPr>
          <a:xfrm>
            <a:off x="0" y="0"/>
            <a:ext cx="3380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b</a:t>
            </a:r>
          </a:p>
        </p:txBody>
      </p:sp>
    </p:spTree>
    <p:extLst>
      <p:ext uri="{BB962C8B-B14F-4D97-AF65-F5344CB8AC3E}">
        <p14:creationId xmlns:p14="http://schemas.microsoft.com/office/powerpoint/2010/main" val="21072481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F9A7C70-11FF-596C-A9F6-160361F5C127}"/>
              </a:ext>
            </a:extLst>
          </p:cNvPr>
          <p:cNvSpPr txBox="1"/>
          <p:nvPr/>
        </p:nvSpPr>
        <p:spPr>
          <a:xfrm>
            <a:off x="358679" y="284787"/>
            <a:ext cx="2404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hatbots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1AC2362E-A7ED-A116-BF9C-784EF72833D5}"/>
              </a:ext>
            </a:extLst>
          </p:cNvPr>
          <p:cNvGrpSpPr/>
          <p:nvPr/>
        </p:nvGrpSpPr>
        <p:grpSpPr>
          <a:xfrm>
            <a:off x="627303" y="1644892"/>
            <a:ext cx="10937394" cy="3946031"/>
            <a:chOff x="627303" y="1644892"/>
            <a:chExt cx="10937394" cy="3946031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8AB2A2D0-8900-F598-767F-7DF26973DB2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43615760"/>
                </p:ext>
              </p:extLst>
            </p:nvPr>
          </p:nvGraphicFramePr>
          <p:xfrm>
            <a:off x="627303" y="1798780"/>
            <a:ext cx="10937394" cy="379214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6263ED7-2F8E-F118-1E68-DF9FE0DA875E}"/>
                </a:ext>
              </a:extLst>
            </p:cNvPr>
            <p:cNvSpPr txBox="1"/>
            <p:nvPr/>
          </p:nvSpPr>
          <p:spPr>
            <a:xfrm>
              <a:off x="2381057" y="1644892"/>
              <a:ext cx="29702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/>
                <a:t>Genetics Professionals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1848A36-22A9-DD4C-EE6D-5C980E48792C}"/>
                </a:ext>
              </a:extLst>
            </p:cNvPr>
            <p:cNvSpPr txBox="1"/>
            <p:nvPr/>
          </p:nvSpPr>
          <p:spPr>
            <a:xfrm>
              <a:off x="2207491" y="3464018"/>
              <a:ext cx="29702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/>
                <a:t>Genetics Counseling Students 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5A26A8E9-9824-DD66-CF1B-10B82CE509AC}"/>
              </a:ext>
            </a:extLst>
          </p:cNvPr>
          <p:cNvSpPr txBox="1"/>
          <p:nvPr/>
        </p:nvSpPr>
        <p:spPr>
          <a:xfrm>
            <a:off x="0" y="23177"/>
            <a:ext cx="3380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c</a:t>
            </a:r>
          </a:p>
        </p:txBody>
      </p:sp>
    </p:spTree>
    <p:extLst>
      <p:ext uri="{BB962C8B-B14F-4D97-AF65-F5344CB8AC3E}">
        <p14:creationId xmlns:p14="http://schemas.microsoft.com/office/powerpoint/2010/main" val="40745313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F9A7C70-11FF-596C-A9F6-160361F5C127}"/>
              </a:ext>
            </a:extLst>
          </p:cNvPr>
          <p:cNvSpPr txBox="1"/>
          <p:nvPr/>
        </p:nvSpPr>
        <p:spPr>
          <a:xfrm>
            <a:off x="358679" y="389409"/>
            <a:ext cx="2404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LMS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C278534A-34AC-AC05-CF7C-B21A970EC4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1971197"/>
              </p:ext>
            </p:extLst>
          </p:nvPr>
        </p:nvGraphicFramePr>
        <p:xfrm>
          <a:off x="358679" y="1363314"/>
          <a:ext cx="11620886" cy="4735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59F6728B-801B-7CE2-DDEC-EEE8599F70E5}"/>
              </a:ext>
            </a:extLst>
          </p:cNvPr>
          <p:cNvSpPr txBox="1"/>
          <p:nvPr/>
        </p:nvSpPr>
        <p:spPr>
          <a:xfrm>
            <a:off x="2279457" y="3648159"/>
            <a:ext cx="2970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Genetics Counseling Students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5E25DA3-A737-7F4A-9AC5-0351ECE4F640}"/>
              </a:ext>
            </a:extLst>
          </p:cNvPr>
          <p:cNvSpPr txBox="1"/>
          <p:nvPr/>
        </p:nvSpPr>
        <p:spPr>
          <a:xfrm>
            <a:off x="2279457" y="1363314"/>
            <a:ext cx="2970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Genetics Professional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0BD613E-4B24-5D89-FE91-5375A9D01921}"/>
              </a:ext>
            </a:extLst>
          </p:cNvPr>
          <p:cNvSpPr txBox="1"/>
          <p:nvPr/>
        </p:nvSpPr>
        <p:spPr>
          <a:xfrm>
            <a:off x="0" y="0"/>
            <a:ext cx="3380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d</a:t>
            </a:r>
          </a:p>
        </p:txBody>
      </p:sp>
    </p:spTree>
    <p:extLst>
      <p:ext uri="{BB962C8B-B14F-4D97-AF65-F5344CB8AC3E}">
        <p14:creationId xmlns:p14="http://schemas.microsoft.com/office/powerpoint/2010/main" val="12943387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F9A7C70-11FF-596C-A9F6-160361F5C127}"/>
              </a:ext>
            </a:extLst>
          </p:cNvPr>
          <p:cNvSpPr txBox="1"/>
          <p:nvPr/>
        </p:nvSpPr>
        <p:spPr>
          <a:xfrm>
            <a:off x="303261" y="338835"/>
            <a:ext cx="50445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Pedigrees and medical summaries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8A6E4A45-1508-2E03-36E9-47F136EE32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6622833"/>
              </p:ext>
            </p:extLst>
          </p:nvPr>
        </p:nvGraphicFramePr>
        <p:xfrm>
          <a:off x="303261" y="1667368"/>
          <a:ext cx="11057466" cy="3468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4B1677F8-8CF4-CC92-9569-55724ABB9BE9}"/>
              </a:ext>
            </a:extLst>
          </p:cNvPr>
          <p:cNvSpPr txBox="1"/>
          <p:nvPr/>
        </p:nvSpPr>
        <p:spPr>
          <a:xfrm>
            <a:off x="2233275" y="1513479"/>
            <a:ext cx="2970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Genetics Professional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4E21AD-C255-25FA-19F8-C0BD15CD17F9}"/>
              </a:ext>
            </a:extLst>
          </p:cNvPr>
          <p:cNvSpPr txBox="1"/>
          <p:nvPr/>
        </p:nvSpPr>
        <p:spPr>
          <a:xfrm>
            <a:off x="1782618" y="3121223"/>
            <a:ext cx="2970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Genetics Counseling Students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5DCA914-37ED-043A-B332-12355355EC9B}"/>
              </a:ext>
            </a:extLst>
          </p:cNvPr>
          <p:cNvSpPr txBox="1"/>
          <p:nvPr/>
        </p:nvSpPr>
        <p:spPr>
          <a:xfrm>
            <a:off x="0" y="0"/>
            <a:ext cx="3380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e</a:t>
            </a:r>
          </a:p>
        </p:txBody>
      </p:sp>
    </p:spTree>
    <p:extLst>
      <p:ext uri="{BB962C8B-B14F-4D97-AF65-F5344CB8AC3E}">
        <p14:creationId xmlns:p14="http://schemas.microsoft.com/office/powerpoint/2010/main" val="19071420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F9A7C70-11FF-596C-A9F6-160361F5C127}"/>
              </a:ext>
            </a:extLst>
          </p:cNvPr>
          <p:cNvSpPr txBox="1"/>
          <p:nvPr/>
        </p:nvSpPr>
        <p:spPr>
          <a:xfrm>
            <a:off x="358679" y="284787"/>
            <a:ext cx="2404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Risk assessment</a:t>
            </a:r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C06CCC58-7BE4-9B9F-64CF-8157C60D869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3378750"/>
              </p:ext>
            </p:extLst>
          </p:nvPr>
        </p:nvGraphicFramePr>
        <p:xfrm>
          <a:off x="129309" y="942109"/>
          <a:ext cx="11896436" cy="48398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CD53182B-04A9-6A92-DF5B-D234FDA33F3B}"/>
              </a:ext>
            </a:extLst>
          </p:cNvPr>
          <p:cNvSpPr txBox="1"/>
          <p:nvPr/>
        </p:nvSpPr>
        <p:spPr>
          <a:xfrm>
            <a:off x="2926003" y="965199"/>
            <a:ext cx="2970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Genetics Professional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2A11987-8C76-4E2A-7AD4-5C2C11A510EF}"/>
              </a:ext>
            </a:extLst>
          </p:cNvPr>
          <p:cNvSpPr txBox="1"/>
          <p:nvPr/>
        </p:nvSpPr>
        <p:spPr>
          <a:xfrm>
            <a:off x="2113203" y="3275111"/>
            <a:ext cx="2970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Genetics Counseling Students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3E1F06B-ACC1-AE82-E7BB-D54B3227E565}"/>
              </a:ext>
            </a:extLst>
          </p:cNvPr>
          <p:cNvSpPr txBox="1"/>
          <p:nvPr/>
        </p:nvSpPr>
        <p:spPr>
          <a:xfrm>
            <a:off x="0" y="0"/>
            <a:ext cx="3380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2f</a:t>
            </a:r>
          </a:p>
        </p:txBody>
      </p:sp>
    </p:spTree>
    <p:extLst>
      <p:ext uri="{BB962C8B-B14F-4D97-AF65-F5344CB8AC3E}">
        <p14:creationId xmlns:p14="http://schemas.microsoft.com/office/powerpoint/2010/main" val="387335500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C030273-7512-E46B-42D0-4086B863A4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8155" y="1246851"/>
            <a:ext cx="9310368" cy="469674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6E81917-0801-3D7D-A76A-9D35DDEB5263}"/>
              </a:ext>
            </a:extLst>
          </p:cNvPr>
          <p:cNvSpPr txBox="1"/>
          <p:nvPr/>
        </p:nvSpPr>
        <p:spPr>
          <a:xfrm>
            <a:off x="489527" y="332509"/>
            <a:ext cx="26693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3</a:t>
            </a:r>
          </a:p>
        </p:txBody>
      </p:sp>
    </p:spTree>
    <p:extLst>
      <p:ext uri="{BB962C8B-B14F-4D97-AF65-F5344CB8AC3E}">
        <p14:creationId xmlns:p14="http://schemas.microsoft.com/office/powerpoint/2010/main" val="3272586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b25db39-86db-462c-bb85-f3ea4045ad49">
      <Terms xmlns="http://schemas.microsoft.com/office/infopath/2007/PartnerControls"/>
    </lcf76f155ced4ddcb4097134ff3c332f>
    <TaxCatchAll xmlns="f4d5f980-7402-491b-a3c1-a3298e9cc04b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8167CF01DBF90498E7A526AA8CF1A8C" ma:contentTypeVersion="19" ma:contentTypeDescription="Create a new document." ma:contentTypeScope="" ma:versionID="a76d47c3f2274de6e37b89f3eb25c731">
  <xsd:schema xmlns:xsd="http://www.w3.org/2001/XMLSchema" xmlns:xs="http://www.w3.org/2001/XMLSchema" xmlns:p="http://schemas.microsoft.com/office/2006/metadata/properties" xmlns:ns2="8b25db39-86db-462c-bb85-f3ea4045ad49" xmlns:ns3="f4d5f980-7402-491b-a3c1-a3298e9cc04b" targetNamespace="http://schemas.microsoft.com/office/2006/metadata/properties" ma:root="true" ma:fieldsID="9dfdb92f63cce25a777dd1b93c137ad9" ns2:_="" ns3:_="">
    <xsd:import namespace="8b25db39-86db-462c-bb85-f3ea4045ad49"/>
    <xsd:import namespace="f4d5f980-7402-491b-a3c1-a3298e9cc04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DateTaken" minOccurs="0"/>
                <xsd:element ref="ns3:SharedWithUsers" minOccurs="0"/>
                <xsd:element ref="ns3:SharedWithDetails" minOccurs="0"/>
                <xsd:element ref="ns2:MediaLengthInSeconds" minOccurs="0"/>
                <xsd:element ref="ns3:TaxCatchAll" minOccurs="0"/>
                <xsd:element ref="ns2:lcf76f155ced4ddcb4097134ff3c332f" minOccurs="0"/>
                <xsd:element ref="ns2:MediaServiceLocation" minOccurs="0"/>
                <xsd:element ref="ns2:MediaServiceObjectDetectorVersions" minOccurs="0"/>
                <xsd:element ref="ns2:MediaServiceSearchPropertie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b25db39-86db-462c-bb85-f3ea4045ad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0" nillable="true" ma:taxonomy="true" ma:internalName="lcf76f155ced4ddcb4097134ff3c332f" ma:taxonomyFieldName="MediaServiceImageTags" ma:displayName="Image Tags" ma:readOnly="false" ma:fieldId="{5cf76f15-5ced-4ddc-b409-7134ff3c332f}" ma:taxonomyMulti="true" ma:sspId="8ce9f98e-9ad5-43de-b59a-72d7e946aae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  <xsd:element name="MediaServiceObjectDetectorVersions" ma:index="22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4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4d5f980-7402-491b-a3c1-a3298e9cc04b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8" nillable="true" ma:displayName="Taxonomy Catch All Column" ma:hidden="true" ma:list="{8da89cc3-c9c0-4fe8-8b9b-fe75d8943836}" ma:internalName="TaxCatchAll" ma:showField="CatchAllData" ma:web="f4d5f980-7402-491b-a3c1-a3298e9cc04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526B61D-7A6D-4513-9CD2-314DC55539F5}">
  <ds:schemaRefs>
    <ds:schemaRef ds:uri="http://purl.org/dc/dcmitype/"/>
    <ds:schemaRef ds:uri="http://schemas.microsoft.com/office/infopath/2007/PartnerControls"/>
    <ds:schemaRef ds:uri="http://purl.org/dc/terms/"/>
    <ds:schemaRef ds:uri="http://schemas.microsoft.com/office/2006/metadata/properties"/>
    <ds:schemaRef ds:uri="http://schemas.openxmlformats.org/package/2006/metadata/core-properties"/>
    <ds:schemaRef ds:uri="http://purl.org/dc/elements/1.1/"/>
    <ds:schemaRef ds:uri="http://schemas.microsoft.com/office/2006/documentManagement/types"/>
    <ds:schemaRef ds:uri="f4d5f980-7402-491b-a3c1-a3298e9cc04b"/>
    <ds:schemaRef ds:uri="8b25db39-86db-462c-bb85-f3ea4045ad49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5EE3BD8E-DD0A-4A25-9B44-772B885E7AA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b25db39-86db-462c-bb85-f3ea4045ad49"/>
    <ds:schemaRef ds:uri="f4d5f980-7402-491b-a3c1-a3298e9cc04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D3711378-568E-4612-BE9D-A147F7190B57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14b77578-9773-42d5-8507-251ca2dc2b06}" enabled="0" method="" siteId="{14b77578-9773-42d5-8507-251ca2dc2b06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20226</TotalTime>
  <Words>177</Words>
  <Application>Microsoft Office PowerPoint</Application>
  <PresentationFormat>Widescreen</PresentationFormat>
  <Paragraphs>7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ptos</vt:lpstr>
      <vt:lpstr>Arial</vt:lpstr>
      <vt:lpstr>Calibri</vt:lpstr>
      <vt:lpstr>Calibri Light</vt:lpstr>
      <vt:lpstr>Office Theme</vt:lpstr>
      <vt:lpstr>Age and experien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HGR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ikel, Rebekah (NIH/NHGRI) [E]</dc:creator>
  <cp:lastModifiedBy>Waikel, Rebekah (NIH/NHGRI) [E]</cp:lastModifiedBy>
  <cp:revision>5</cp:revision>
  <dcterms:created xsi:type="dcterms:W3CDTF">2024-05-12T16:29:58Z</dcterms:created>
  <dcterms:modified xsi:type="dcterms:W3CDTF">2025-04-30T15:41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8167CF01DBF90498E7A526AA8CF1A8C</vt:lpwstr>
  </property>
  <property fmtid="{D5CDD505-2E9C-101B-9397-08002B2CF9AE}" pid="3" name="MediaServiceImageTags">
    <vt:lpwstr/>
  </property>
</Properties>
</file>